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9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08"/>
    <p:restoredTop sz="94679"/>
  </p:normalViewPr>
  <p:slideViewPr>
    <p:cSldViewPr snapToGrid="0" snapToObjects="1" showGuides="1">
      <p:cViewPr>
        <p:scale>
          <a:sx n="141" d="100"/>
          <a:sy n="141" d="100"/>
        </p:scale>
        <p:origin x="1272" y="-453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EF798-C78A-0347-BF8A-A0A354A795C2}" type="datetimeFigureOut">
              <a:rPr lang="en-US" smtClean="0"/>
              <a:t>2/27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969C2-3D3F-4842-8749-B4432BB6696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EF798-C78A-0347-BF8A-A0A354A795C2}" type="datetimeFigureOut">
              <a:rPr lang="en-US" smtClean="0"/>
              <a:t>2/27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969C2-3D3F-4842-8749-B4432BB6696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EF798-C78A-0347-BF8A-A0A354A795C2}" type="datetimeFigureOut">
              <a:rPr lang="en-US" smtClean="0"/>
              <a:t>2/27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969C2-3D3F-4842-8749-B4432BB6696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EF798-C78A-0347-BF8A-A0A354A795C2}" type="datetimeFigureOut">
              <a:rPr lang="en-US" smtClean="0"/>
              <a:t>2/27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969C2-3D3F-4842-8749-B4432BB6696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EF798-C78A-0347-BF8A-A0A354A795C2}" type="datetimeFigureOut">
              <a:rPr lang="en-US" smtClean="0"/>
              <a:t>2/27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969C2-3D3F-4842-8749-B4432BB6696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EF798-C78A-0347-BF8A-A0A354A795C2}" type="datetimeFigureOut">
              <a:rPr lang="en-US" smtClean="0"/>
              <a:t>2/27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969C2-3D3F-4842-8749-B4432BB6696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EF798-C78A-0347-BF8A-A0A354A795C2}" type="datetimeFigureOut">
              <a:rPr lang="en-US" smtClean="0"/>
              <a:t>2/27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969C2-3D3F-4842-8749-B4432BB6696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EF798-C78A-0347-BF8A-A0A354A795C2}" type="datetimeFigureOut">
              <a:rPr lang="en-US" smtClean="0"/>
              <a:t>2/27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969C2-3D3F-4842-8749-B4432BB6696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EF798-C78A-0347-BF8A-A0A354A795C2}" type="datetimeFigureOut">
              <a:rPr lang="en-US" smtClean="0"/>
              <a:t>2/27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969C2-3D3F-4842-8749-B4432BB6696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EF798-C78A-0347-BF8A-A0A354A795C2}" type="datetimeFigureOut">
              <a:rPr lang="en-US" smtClean="0"/>
              <a:t>2/27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969C2-3D3F-4842-8749-B4432BB6696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EF798-C78A-0347-BF8A-A0A354A795C2}" type="datetimeFigureOut">
              <a:rPr lang="en-US" smtClean="0"/>
              <a:t>2/27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969C2-3D3F-4842-8749-B4432BB6696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CEF798-C78A-0347-BF8A-A0A354A795C2}" type="datetimeFigureOut">
              <a:rPr lang="en-US" smtClean="0"/>
              <a:t>2/27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C969C2-3D3F-4842-8749-B4432BB669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98064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ontent Placeholder 2"/>
          <p:cNvSpPr>
            <a:spLocks noGrp="1"/>
          </p:cNvSpPr>
          <p:nvPr>
            <p:ph idx="1"/>
          </p:nvPr>
        </p:nvSpPr>
        <p:spPr>
          <a:xfrm>
            <a:off x="521563" y="536473"/>
            <a:ext cx="5708756" cy="2447628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sz="1400" dirty="0" smtClean="0"/>
              <a:t>Drug-resistance </a:t>
            </a:r>
            <a:r>
              <a:rPr lang="en-US" sz="1400" dirty="0"/>
              <a:t>phenotype frequency table by </a:t>
            </a:r>
            <a:r>
              <a:rPr lang="en-US" sz="1400" dirty="0" smtClean="0"/>
              <a:t>lineage</a:t>
            </a:r>
            <a:r>
              <a:rPr lang="en-US" sz="1400" smtClean="0"/>
              <a:t>; ‘Total’ </a:t>
            </a:r>
            <a:r>
              <a:rPr lang="en-US" sz="1400" dirty="0"/>
              <a:t>shows the number and percentage by lineage of known drug-resistance phenotypes.</a:t>
            </a:r>
          </a:p>
          <a:p>
            <a:pPr marL="0" indent="0">
              <a:buNone/>
            </a:pPr>
            <a:r>
              <a:rPr lang="en-US" sz="1400" b="1" dirty="0" smtClean="0"/>
              <a:t> </a:t>
            </a:r>
            <a:endParaRPr lang="en-US" sz="1400" dirty="0"/>
          </a:p>
        </p:txBody>
      </p:sp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30075988"/>
              </p:ext>
            </p:extLst>
          </p:nvPr>
        </p:nvGraphicFramePr>
        <p:xfrm>
          <a:off x="909940" y="1358664"/>
          <a:ext cx="4932002" cy="6284915"/>
        </p:xfrm>
        <a:graphic>
          <a:graphicData uri="http://schemas.openxmlformats.org/drawingml/2006/table">
            <a:tbl>
              <a:tblPr>
                <a:tableStyleId>{616DA210-FB5B-4158-B5E0-FEB733F419BA}</a:tableStyleId>
              </a:tblPr>
              <a:tblGrid>
                <a:gridCol w="604870"/>
                <a:gridCol w="604870"/>
                <a:gridCol w="604870"/>
                <a:gridCol w="651391"/>
                <a:gridCol w="604870"/>
                <a:gridCol w="651391"/>
                <a:gridCol w="604870"/>
                <a:gridCol w="604870"/>
              </a:tblGrid>
              <a:tr h="179569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u="none" strike="noStrike">
                          <a:effectLst/>
                        </a:rPr>
                        <a:t>Drug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u="none" strike="noStrike">
                          <a:effectLst/>
                        </a:rPr>
                        <a:t>Lineage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 gridSpan="2">
                  <a:txBody>
                    <a:bodyPr/>
                    <a:lstStyle/>
                    <a:p>
                      <a:pPr algn="ctr" rtl="0" fontAlgn="b"/>
                      <a:r>
                        <a:rPr lang="en-US" sz="1000" u="none" strike="noStrike">
                          <a:effectLst/>
                        </a:rPr>
                        <a:t>Suseptible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b"/>
                      <a:r>
                        <a:rPr lang="en-US" sz="1000" u="none" strike="noStrike">
                          <a:effectLst/>
                        </a:rPr>
                        <a:t>Resistant 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b"/>
                      <a:r>
                        <a:rPr lang="en-US" sz="1000" u="none" strike="noStrike">
                          <a:effectLst/>
                        </a:rPr>
                        <a:t>Total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79569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u="none" strike="noStrike">
                          <a:effectLst/>
                        </a:rPr>
                        <a:t>MDR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u="none" strike="noStrike">
                          <a:effectLst/>
                        </a:rPr>
                        <a:t>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32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64.3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18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35.7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51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72.6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</a:tr>
              <a:tr h="179569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u="none" strike="noStrike">
                          <a:effectLst/>
                        </a:rPr>
                        <a:t>MDR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u="none" strike="noStrike">
                          <a:effectLst/>
                        </a:rPr>
                        <a:t>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270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90.5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28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9.5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298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80.7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</a:tr>
              <a:tr h="179569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u="none" strike="noStrike">
                          <a:effectLst/>
                        </a:rPr>
                        <a:t>XDR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u="none" strike="noStrike">
                          <a:effectLst/>
                        </a:rPr>
                        <a:t>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32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90.1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3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9.9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36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51.9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</a:tr>
              <a:tr h="179569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u="none" strike="noStrike">
                          <a:effectLst/>
                        </a:rPr>
                        <a:t>XDR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u="none" strike="noStrike">
                          <a:effectLst/>
                        </a:rPr>
                        <a:t>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270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98.8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3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1.2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273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73.9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</a:tr>
              <a:tr h="179569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u="none" strike="noStrike">
                          <a:effectLst/>
                        </a:rPr>
                        <a:t>XDRvMDR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u="none" strike="noStrike">
                          <a:effectLst/>
                        </a:rPr>
                        <a:t>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18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83.5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3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16.5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21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31.1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</a:tr>
              <a:tr h="179569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u="none" strike="noStrike">
                          <a:effectLst/>
                        </a:rPr>
                        <a:t>XDRvMDR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u="none" strike="noStrike">
                          <a:effectLst/>
                        </a:rPr>
                        <a:t>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28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89.3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3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10.7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31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8.6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</a:tr>
              <a:tr h="179569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u="none" strike="noStrike">
                          <a:effectLst/>
                        </a:rPr>
                        <a:t>FQ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u="none" strike="noStrike">
                          <a:effectLst/>
                        </a:rPr>
                        <a:t>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23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75.1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7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24.9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31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44.6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</a:tr>
              <a:tr h="179569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u="none" strike="noStrike">
                          <a:effectLst/>
                        </a:rPr>
                        <a:t>FQ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u="none" strike="noStrike">
                          <a:effectLst/>
                        </a:rPr>
                        <a:t>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69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87.8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9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12.2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78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21.3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</a:tr>
              <a:tr h="179569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u="none" strike="noStrike">
                          <a:effectLst/>
                        </a:rPr>
                        <a:t>AG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u="none" strike="noStrike">
                          <a:effectLst/>
                        </a:rPr>
                        <a:t>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5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75.3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24.7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7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1.0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</a:tr>
              <a:tr h="179569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u="none" strike="noStrike">
                          <a:effectLst/>
                        </a:rPr>
                        <a:t>AG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u="none" strike="noStrike">
                          <a:effectLst/>
                        </a:rPr>
                        <a:t>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26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75.0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8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25.0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34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9.4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</a:tr>
              <a:tr h="179569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u="none" strike="noStrike">
                          <a:effectLst/>
                        </a:rPr>
                        <a:t>RMP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u="none" strike="noStrike">
                          <a:effectLst/>
                        </a:rPr>
                        <a:t>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36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59.2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25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40.8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61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87.6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</a:tr>
              <a:tr h="179569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u="none" strike="noStrike">
                          <a:effectLst/>
                        </a:rPr>
                        <a:t>RMP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u="none" strike="noStrike">
                          <a:effectLst/>
                        </a:rPr>
                        <a:t>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297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86.4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46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13.6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344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92.8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</a:tr>
              <a:tr h="179569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u="none" strike="noStrike">
                          <a:effectLst/>
                        </a:rPr>
                        <a:t>IN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u="none" strike="noStrike">
                          <a:effectLst/>
                        </a:rPr>
                        <a:t>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35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57.9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25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42.1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61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87.0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</a:tr>
              <a:tr h="179569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u="none" strike="noStrike">
                          <a:effectLst/>
                        </a:rPr>
                        <a:t>IN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u="none" strike="noStrike">
                          <a:effectLst/>
                        </a:rPr>
                        <a:t>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277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82.5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58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17.5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335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90.6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</a:tr>
              <a:tr h="179569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u="none" strike="noStrike">
                          <a:effectLst/>
                        </a:rPr>
                        <a:t>EMB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u="none" strike="noStrike">
                          <a:effectLst/>
                        </a:rPr>
                        <a:t>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41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77.1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12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22.9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53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75.9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</a:tr>
              <a:tr h="179569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u="none" strike="noStrike">
                          <a:effectLst/>
                        </a:rPr>
                        <a:t>EMB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u="none" strike="noStrike">
                          <a:effectLst/>
                        </a:rPr>
                        <a:t>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236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93.5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16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6.5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252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68.1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</a:tr>
              <a:tr h="179569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u="none" strike="noStrike">
                          <a:effectLst/>
                        </a:rPr>
                        <a:t>PZ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u="none" strike="noStrike">
                          <a:effectLst/>
                        </a:rPr>
                        <a:t>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28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86.7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4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13.3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32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46.2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</a:tr>
              <a:tr h="179569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u="none" strike="noStrike">
                          <a:effectLst/>
                        </a:rPr>
                        <a:t>PZ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u="none" strike="noStrike">
                          <a:effectLst/>
                        </a:rPr>
                        <a:t>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201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95.6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9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4.4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211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57.0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</a:tr>
              <a:tr h="179569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u="none" strike="noStrike">
                          <a:effectLst/>
                        </a:rPr>
                        <a:t>STREP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u="none" strike="noStrike">
                          <a:effectLst/>
                        </a:rPr>
                        <a:t>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22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57.0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16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43.0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39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55.7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</a:tr>
              <a:tr h="179569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u="none" strike="noStrike">
                          <a:effectLst/>
                        </a:rPr>
                        <a:t>STREP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u="none" strike="noStrike">
                          <a:effectLst/>
                        </a:rPr>
                        <a:t>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149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84.7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27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15.3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177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47.8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</a:tr>
              <a:tr h="179569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u="none" strike="noStrike">
                          <a:effectLst/>
                        </a:rPr>
                        <a:t>CIP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u="none" strike="noStrike">
                          <a:effectLst/>
                        </a:rPr>
                        <a:t>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2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91.7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8.3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2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3.4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</a:tr>
              <a:tr h="179569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u="none" strike="noStrike">
                          <a:effectLst/>
                        </a:rPr>
                        <a:t>CIP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u="none" strike="noStrike">
                          <a:effectLst/>
                        </a:rPr>
                        <a:t>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14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87.5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2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12.5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16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4.3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</a:tr>
              <a:tr h="179569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u="none" strike="noStrike">
                          <a:effectLst/>
                        </a:rPr>
                        <a:t>MOX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u="none" strike="noStrike">
                          <a:effectLst/>
                        </a:rPr>
                        <a:t>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12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93.8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6.3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12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18.2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</a:tr>
              <a:tr h="179569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u="none" strike="noStrike">
                          <a:effectLst/>
                        </a:rPr>
                        <a:t>MOX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u="none" strike="noStrike">
                          <a:effectLst/>
                        </a:rPr>
                        <a:t>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32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96.7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1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3.3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33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8.9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</a:tr>
              <a:tr h="179569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u="none" strike="noStrike">
                          <a:effectLst/>
                        </a:rPr>
                        <a:t>OFL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u="none" strike="noStrike">
                          <a:effectLst/>
                        </a:rPr>
                        <a:t>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10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61.2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6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38.8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17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25.4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</a:tr>
              <a:tr h="179569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u="none" strike="noStrike">
                          <a:effectLst/>
                        </a:rPr>
                        <a:t>OFL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u="none" strike="noStrike">
                          <a:effectLst/>
                        </a:rPr>
                        <a:t>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28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79.2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7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20.8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35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9.6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</a:tr>
              <a:tr h="179569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u="none" strike="noStrike">
                          <a:effectLst/>
                        </a:rPr>
                        <a:t>KAN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u="none" strike="noStrike">
                          <a:effectLst/>
                        </a:rPr>
                        <a:t>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17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86.0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2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14.0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20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29.5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</a:tr>
              <a:tr h="179569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u="none" strike="noStrike">
                          <a:effectLst/>
                        </a:rPr>
                        <a:t>KAN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u="none" strike="noStrike">
                          <a:effectLst/>
                        </a:rPr>
                        <a:t>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37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92.4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3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7.6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41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11.1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</a:tr>
              <a:tr h="179569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u="none" strike="noStrike">
                          <a:effectLst/>
                        </a:rPr>
                        <a:t>AMK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u="none" strike="noStrike">
                          <a:effectLst/>
                        </a:rPr>
                        <a:t>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12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79.6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3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20.4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15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21.7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</a:tr>
              <a:tr h="179569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u="none" strike="noStrike">
                          <a:effectLst/>
                        </a:rPr>
                        <a:t>AMK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u="none" strike="noStrike">
                          <a:effectLst/>
                        </a:rPr>
                        <a:t>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51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94.4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3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5.6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54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14.6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</a:tr>
              <a:tr h="179569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u="none" strike="noStrike">
                          <a:effectLst/>
                        </a:rPr>
                        <a:t>CAP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u="none" strike="noStrike">
                          <a:effectLst/>
                        </a:rPr>
                        <a:t>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21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88.6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2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11.4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24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35.0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</a:tr>
              <a:tr h="179569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u="none" strike="noStrike">
                          <a:effectLst/>
                        </a:rPr>
                        <a:t>CAP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u="none" strike="noStrike">
                          <a:effectLst/>
                        </a:rPr>
                        <a:t>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53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92.7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4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7.3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57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15.5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</a:tr>
              <a:tr h="179569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u="none" strike="noStrike">
                          <a:effectLst/>
                        </a:rPr>
                        <a:t>ET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u="none" strike="noStrike">
                          <a:effectLst/>
                        </a:rPr>
                        <a:t>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13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76.0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4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24.0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17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24.4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</a:tr>
              <a:tr h="179569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u="none" strike="noStrike">
                          <a:effectLst/>
                        </a:rPr>
                        <a:t>ET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u="none" strike="noStrike">
                          <a:effectLst/>
                        </a:rPr>
                        <a:t>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24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86.6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3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13.4%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27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dirty="0">
                          <a:effectLst/>
                        </a:rPr>
                        <a:t>7.5%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0563" marR="10563" marT="10563" marB="0" anchor="b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0743763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</TotalTime>
  <Words>402</Words>
  <Application>Microsoft Macintosh PowerPoint</Application>
  <PresentationFormat>A4 Paper (210x297 mm)</PresentationFormat>
  <Paragraphs>27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Calibri</vt:lpstr>
      <vt:lpstr>Calibri Light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28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Oppong, Yaa</dc:creator>
  <cp:lastModifiedBy>Oppong, Yaa</cp:lastModifiedBy>
  <cp:revision>4</cp:revision>
  <dcterms:created xsi:type="dcterms:W3CDTF">2018-02-14T14:03:39Z</dcterms:created>
  <dcterms:modified xsi:type="dcterms:W3CDTF">2018-02-27T13:43:49Z</dcterms:modified>
</cp:coreProperties>
</file>